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3802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77086-E9B0-4BE9-B100-10EB52410E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62722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53680" y="4130640"/>
            <a:ext cx="62722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A5F7F-9AC6-4155-9969-AA792723DC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67760" y="198108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53680" y="413064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67760" y="413064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F94ED-69C0-40F6-96BB-9164A55120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201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4800" y="1981080"/>
            <a:ext cx="201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95560" y="1981080"/>
            <a:ext cx="201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53680" y="4130640"/>
            <a:ext cx="201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4800" y="4130640"/>
            <a:ext cx="201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95560" y="4130640"/>
            <a:ext cx="201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DD9D8-4A37-4FBE-80E4-5ADFC02F11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53680" y="1981080"/>
            <a:ext cx="627228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9818F-C58E-49B6-94F1-56285702CD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62722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669CF-90CD-4B90-A3B8-6920B44386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30607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67760" y="1981080"/>
            <a:ext cx="30607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09FFF-37F9-4C42-9A82-FBF8B625C0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61D5B-260F-4798-833D-E40C063DC0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53680" y="609120"/>
            <a:ext cx="627228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82B8B-1F30-4AC7-89E3-0B70CC2776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67760" y="1981080"/>
            <a:ext cx="30607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53680" y="413064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9B5AB-F167-4904-84B5-4DC40D4CDB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30607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67760" y="198108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67760" y="413064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F3F8A-657D-4B00-8938-17EABEA5F5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53680" y="198108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67760" y="1981080"/>
            <a:ext cx="30607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53680" y="4130640"/>
            <a:ext cx="62722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B97D3-6751-4C2E-B2A4-C415870FBE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53680" y="609120"/>
            <a:ext cx="6272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53680" y="1981080"/>
            <a:ext cx="62722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5880" indent="-3358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27920" indent="-280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19960" indent="-22392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68160" indent="-22392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16000" indent="-22392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16000" indent="-22392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16000" indent="-22392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53680" y="6248520"/>
            <a:ext cx="1536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20720" y="6248520"/>
            <a:ext cx="23382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89120" y="6248520"/>
            <a:ext cx="1536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4AA811-08EC-4C02-84B8-499AFB4426C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01760" y="961920"/>
            <a:ext cx="1008000" cy="470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Conversion to Fasta forma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1757520" y="961920"/>
            <a:ext cx="1008000" cy="470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Vector clipping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527720" y="1773360"/>
            <a:ext cx="1008000" cy="471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Insert into databas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132000" y="961920"/>
            <a:ext cx="1009800" cy="470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RE cutting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30120" y="152280"/>
            <a:ext cx="1136880" cy="48276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Upload sequence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898560" y="635040"/>
            <a:ext cx="0" cy="331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409760" y="1197000"/>
            <a:ext cx="3477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765520" y="1197000"/>
            <a:ext cx="3636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456080" y="2567160"/>
            <a:ext cx="1136520" cy="48240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Clean sequence tabl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508640" y="961920"/>
            <a:ext cx="1008000" cy="470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Repeat scanning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4141800" y="1192320"/>
            <a:ext cx="361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487760" y="3365640"/>
            <a:ext cx="1009800" cy="469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Retrieve sequences </a:t>
            </a: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free of</a:t>
            </a: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 repe</a:t>
            </a: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at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5043600" y="3049560"/>
            <a:ext cx="0" cy="316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075120" y="3390840"/>
            <a:ext cx="1008000" cy="469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BLAST the sequence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5" name=""/>
          <p:cNvGrpSpPr/>
          <p:nvPr/>
        </p:nvGrpSpPr>
        <p:grpSpPr>
          <a:xfrm>
            <a:off x="544680" y="4265640"/>
            <a:ext cx="2273040" cy="482400"/>
            <a:chOff x="544680" y="4265640"/>
            <a:chExt cx="2273040" cy="482400"/>
          </a:xfrm>
        </p:grpSpPr>
        <p:sp>
          <p:nvSpPr>
            <p:cNvPr id="56" name=""/>
            <p:cNvSpPr/>
            <p:nvPr/>
          </p:nvSpPr>
          <p:spPr>
            <a:xfrm>
              <a:off x="544680" y="4265640"/>
              <a:ext cx="1136520" cy="482400"/>
            </a:xfrm>
            <a:prstGeom prst="ellipse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 anchorCtr="1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ahoma"/>
                </a:rPr>
                <a:t>BLAST hit table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681200" y="4265640"/>
              <a:ext cx="1136520" cy="482400"/>
            </a:xfrm>
            <a:prstGeom prst="ellipse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 anchorCtr="1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ahoma"/>
                </a:rPr>
                <a:t>BLAST hsp table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8" name=""/>
          <p:cNvSpPr/>
          <p:nvPr/>
        </p:nvSpPr>
        <p:spPr>
          <a:xfrm>
            <a:off x="2187720" y="3870360"/>
            <a:ext cx="66600" cy="395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1117080" y="3870360"/>
            <a:ext cx="1070280" cy="395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668600" y="3390840"/>
            <a:ext cx="1009440" cy="469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Insert results into databas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4083120" y="3614760"/>
            <a:ext cx="404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1751040" y="5099040"/>
            <a:ext cx="1008000" cy="469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Retrieve genomic location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266920" y="4751280"/>
            <a:ext cx="0" cy="3477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3110040" y="5099040"/>
            <a:ext cx="1009440" cy="469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Query the Ensembl mouse database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754360" y="5321160"/>
            <a:ext cx="361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424400" y="5942160"/>
            <a:ext cx="1136520" cy="47916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Ensembl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database links tabl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5062680" y="5573880"/>
            <a:ext cx="0" cy="368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487760" y="5099040"/>
            <a:ext cx="1009800" cy="469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xx" sz="900" spc="-1" strike="noStrike">
                <a:solidFill>
                  <a:srgbClr val="000000"/>
                </a:solidFill>
                <a:latin typeface="Tahoma"/>
              </a:rPr>
              <a:t>Insert results into databas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125960" y="5334120"/>
            <a:ext cx="361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2677680" y="361620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3390840" y="2209680"/>
            <a:ext cx="1136880" cy="48276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Change-view parameter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 flipH="1">
            <a:off x="3849840" y="2692440"/>
            <a:ext cx="123840" cy="6984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2168640" y="2209680"/>
            <a:ext cx="1136520" cy="48276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View BLAST run info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2741760" y="2692440"/>
            <a:ext cx="830160" cy="698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929120" y="4276800"/>
            <a:ext cx="1136880" cy="48096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Database viewer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2817360" y="4513320"/>
            <a:ext cx="21114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965160" y="2219400"/>
            <a:ext cx="1136520" cy="48240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Start BLAST run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1538280" y="2701800"/>
            <a:ext cx="1776600" cy="689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1987560" y="5938920"/>
            <a:ext cx="1135080" cy="48240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View Ensembl run info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2579760" y="5568840"/>
            <a:ext cx="1035000" cy="370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287880" y="5938920"/>
            <a:ext cx="1136520" cy="479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Ensembl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gene tabl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3858840" y="5573880"/>
            <a:ext cx="1203480" cy="365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363600" y="6137280"/>
            <a:ext cx="181080" cy="93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63600" y="6311880"/>
            <a:ext cx="181080" cy="9360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692280" y="6121440"/>
            <a:ext cx="933480" cy="12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Program step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692280" y="6296040"/>
            <a:ext cx="822240" cy="12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Data storag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692280" y="5950080"/>
            <a:ext cx="822240" cy="12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Web pag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363600" y="5965920"/>
            <a:ext cx="181080" cy="93600"/>
          </a:xfrm>
          <a:prstGeom prst="rect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6040440" y="5932440"/>
            <a:ext cx="1135080" cy="48276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Compare w/  “important” list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1111320" y="4724280"/>
            <a:ext cx="0" cy="36828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558720" y="5089680"/>
            <a:ext cx="1135080" cy="48240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Visualize hit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92" name=""/>
          <p:cNvCxnSpPr>
            <a:stCxn id="89" idx="4"/>
            <a:endCxn id="81" idx="4"/>
          </p:cNvCxnSpPr>
          <p:nvPr/>
        </p:nvCxnSpPr>
        <p:spPr>
          <a:xfrm rot="5400000">
            <a:off x="5230440" y="5040720"/>
            <a:ext cx="3600" cy="2752200"/>
          </a:xfrm>
          <a:prstGeom prst="bentConnector3">
            <a:avLst>
              <a:gd name="adj1" fmla="val 7266666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3" name=""/>
          <p:cNvCxnSpPr>
            <a:stCxn id="75" idx="5"/>
            <a:endCxn id="66" idx="6"/>
          </p:cNvCxnSpPr>
          <p:nvPr/>
        </p:nvCxnSpPr>
        <p:spPr>
          <a:xfrm rot="5400000">
            <a:off x="4982760" y="5265360"/>
            <a:ext cx="1494720" cy="33912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4" name=""/>
          <p:cNvCxnSpPr>
            <a:stCxn id="75" idx="7"/>
            <a:endCxn id="49" idx="6"/>
          </p:cNvCxnSpPr>
          <p:nvPr/>
        </p:nvCxnSpPr>
        <p:spPr>
          <a:xfrm flipV="1" rot="16200000">
            <a:off x="4976640" y="3423960"/>
            <a:ext cx="1539000" cy="30744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5" name=""/>
          <p:cNvSpPr/>
          <p:nvPr/>
        </p:nvSpPr>
        <p:spPr>
          <a:xfrm>
            <a:off x="5043600" y="2259000"/>
            <a:ext cx="0" cy="316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5043600" y="1457280"/>
            <a:ext cx="0" cy="316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4255920" y="390600"/>
            <a:ext cx="291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d. Figure 1, Horsman et al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6040440" y="2575080"/>
            <a:ext cx="1136520" cy="482400"/>
          </a:xfrm>
          <a:prstGeom prst="ellipse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</a:rPr>
              <a:t>View TF binding site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6167520" y="3600360"/>
            <a:ext cx="1008000" cy="470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900" spc="-1" strike="noStrike">
                <a:solidFill>
                  <a:srgbClr val="000000"/>
                </a:solidFill>
                <a:latin typeface="Tahoma"/>
              </a:rPr>
              <a:t>Pattern recognition on sequence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00" name=""/>
          <p:cNvCxnSpPr>
            <a:stCxn id="75" idx="6"/>
            <a:endCxn id="99" idx="2"/>
          </p:cNvCxnSpPr>
          <p:nvPr/>
        </p:nvCxnSpPr>
        <p:spPr>
          <a:xfrm flipV="1">
            <a:off x="6066000" y="4070520"/>
            <a:ext cx="605880" cy="447120"/>
          </a:xfrm>
          <a:prstGeom prst="bentConnector2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101" name=""/>
          <p:cNvSpPr/>
          <p:nvPr/>
        </p:nvSpPr>
        <p:spPr>
          <a:xfrm>
            <a:off x="6653160" y="3057480"/>
            <a:ext cx="0" cy="542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2-09T14:41:04Z</dcterms:created>
  <dc:creator>katsanto</dc:creator>
  <dc:description/>
  <dc:language>en-US</dc:language>
  <cp:lastModifiedBy>ekatsantoni</cp:lastModifiedBy>
  <dcterms:modified xsi:type="dcterms:W3CDTF">2006-02-09T17:10:54Z</dcterms:modified>
  <cp:revision>31</cp:revision>
  <dc:subject/>
  <dc:title>PowerPoint Presentation</dc:title>
</cp:coreProperties>
</file>